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DE175A8-D981-4DCD-870B-FFB7AB13E7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E0E0EDFB-25E0-4A3E-BEC2-CB64A81185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AE253E8-6400-499A-AA9C-4EC18AF90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FE3DAA3-299B-4C7D-9A5E-56B6E8F70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C715F01-F854-4144-950E-AE1D0E5254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4808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15C1CF4-9766-44ED-830B-E1E232DF68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45F7335-90BB-4417-87E5-B32BC2511E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64F825E-39D6-49D1-A673-C9094C08C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9E8F199-D578-4E5B-9682-D784B135CA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A253C42-BFC8-4B0E-AD03-C8A354BD8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0376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43DCE6D-1C2E-4339-86E3-83CDCFEC14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2CD7065-9747-46FE-BF19-2F93D842B9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F51E5C2-8ACC-4215-88A2-ED12F3526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66E27E1-9C50-4C2D-98E4-C45D61A87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FB1C45-557C-4CDF-89B9-31F7B8834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8901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55E9C97-9826-40AE-B720-69E1864226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0A934CE-A915-4F9F-B982-A0E93AD93B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549DF53-101C-4565-BAA6-48FE88EF9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216BDFF-BC77-4C3A-B748-AEBF0FE85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52CEB5A-DA41-471B-9CAE-A79E6B773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3812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77F61A7-DA79-4603-B93F-76DDFEA4D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89AF2ED-FCA8-4D51-A5C5-3596198CEE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001ECAC-16C1-47C3-B5AB-75128E245C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CCC675B-2DD4-4777-9C9B-071F113E1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DD19893-A70F-477A-BA2D-73AFC094C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0728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19C7A27-C113-4D9F-8A13-5FAC8CA641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740B524-7DE6-4D37-9C6C-12DE237056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561FF74-03A9-4841-A94E-C7A61B9F4F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B5EBA49-F84E-4E58-B43F-84664121F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D7B7DDD-7DE8-42F9-AC3E-BE840B873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0C50641-74F0-48A3-AD39-728B928A8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4340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63361D9-E9DF-403A-A959-7B7A1DF90B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48F9F17-8BE9-432A-9515-AE0A7B9574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E83C89A-2D0C-44C2-B0C5-3B572E3446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1BCBE1F-DF34-4F90-8C27-0BE2AD2634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28557D10-0F9D-4382-BECC-89AB7A4AE5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1815B8B-9608-40E6-82D4-4E6E80A55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EB5CDAA1-CF67-445F-B804-35EE00B98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C559C3F-0771-45CE-8080-58C93F827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7920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A10903F-782E-48F3-A3C7-91036F466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A1AD5FE-68B8-4671-9AA1-320EFF567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000CCAA-8ADB-48AC-B7C7-0003CDF60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FF52A9A2-50EC-44F5-A645-D74F826B2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1663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49E29D4-837D-48C5-B638-FD8B44FE2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D3598DE-39EF-4BCF-9CD1-D5AD114CD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FC7F102-415F-43C8-9314-36DC8F642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1797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0F85DF1-AD13-4F7F-9780-B62779583F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A0FFCE3-AD7A-4774-A20A-70B6A38F66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5711DA6-AD78-4AB9-BD4E-99FA3CBFEF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BA5D3E5-9645-4B0C-95F6-F0330AB05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F136F4C-3B34-4E5B-963E-0E6163907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03879AD-1DBE-46A5-92B2-DB6D1DDC3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5239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4826450-CCF2-4715-95EB-035DA3F5A3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2096C43-78CF-4682-951B-C6E8B9A448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DB09AA4-7107-4926-9FEC-63E09DB67C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0709910-1C3F-4F21-B0CB-69FAF7B04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087CD81-E5B0-49A9-B880-894C5A5FF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B6C532E-3CEA-489F-BCF1-AAC1A595B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6956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287AD8F-C844-443C-8AB0-55ACD0DE3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4C5E97D-D686-4EB6-B782-70B2AC7FFF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C115968-7EFF-41D2-9715-35978A175B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28493-D3D5-4E1F-9EF7-B992E04F7B31}" type="datetimeFigureOut">
              <a:rPr lang="it-IT" smtClean="0"/>
              <a:t>20/02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3521A87-FA67-4BDB-A164-3852BFCD8D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589DCCF-7A41-4A65-AF71-2095D921FE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79D95E-2AF7-4A34-A69F-917118FA24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110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id="{7CD0FCE7-604D-4E1C-87C2-A4B92527DA05}"/>
              </a:ext>
            </a:extLst>
          </p:cNvPr>
          <p:cNvSpPr/>
          <p:nvPr/>
        </p:nvSpPr>
        <p:spPr>
          <a:xfrm>
            <a:off x="693826" y="418011"/>
            <a:ext cx="1674905" cy="2946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able</a:t>
            </a:r>
            <a:r>
              <a:rPr kumimoji="0" lang="it-IT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S1</a:t>
            </a:r>
            <a:r>
              <a:rPr lang="it-IT" sz="1000" b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0" lang="it-IT" sz="7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ella 5">
            <a:extLst>
              <a:ext uri="{FF2B5EF4-FFF2-40B4-BE49-F238E27FC236}">
                <a16:creationId xmlns:a16="http://schemas.microsoft.com/office/drawing/2014/main" id="{DE1909D6-5AEC-4F98-B385-C93D52F793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6783527"/>
              </p:ext>
            </p:extLst>
          </p:nvPr>
        </p:nvGraphicFramePr>
        <p:xfrm>
          <a:off x="2994746" y="2626013"/>
          <a:ext cx="5385774" cy="1028701"/>
        </p:xfrm>
        <a:graphic>
          <a:graphicData uri="http://schemas.openxmlformats.org/drawingml/2006/table">
            <a:tbl>
              <a:tblPr firstRow="1" firstCol="1">
                <a:tableStyleId>{9D7B26C5-4107-4FEC-AEDC-1716B250A1EF}</a:tableStyleId>
              </a:tblPr>
              <a:tblGrid>
                <a:gridCol w="849285">
                  <a:extLst>
                    <a:ext uri="{9D8B030D-6E8A-4147-A177-3AD203B41FA5}">
                      <a16:colId xmlns:a16="http://schemas.microsoft.com/office/drawing/2014/main" val="2754193983"/>
                    </a:ext>
                  </a:extLst>
                </a:gridCol>
                <a:gridCol w="1056443">
                  <a:extLst>
                    <a:ext uri="{9D8B030D-6E8A-4147-A177-3AD203B41FA5}">
                      <a16:colId xmlns:a16="http://schemas.microsoft.com/office/drawing/2014/main" val="3394332095"/>
                    </a:ext>
                  </a:extLst>
                </a:gridCol>
                <a:gridCol w="656947">
                  <a:extLst>
                    <a:ext uri="{9D8B030D-6E8A-4147-A177-3AD203B41FA5}">
                      <a16:colId xmlns:a16="http://schemas.microsoft.com/office/drawing/2014/main" val="4272264895"/>
                    </a:ext>
                  </a:extLst>
                </a:gridCol>
                <a:gridCol w="674703">
                  <a:extLst>
                    <a:ext uri="{9D8B030D-6E8A-4147-A177-3AD203B41FA5}">
                      <a16:colId xmlns:a16="http://schemas.microsoft.com/office/drawing/2014/main" val="499580439"/>
                    </a:ext>
                  </a:extLst>
                </a:gridCol>
                <a:gridCol w="790113">
                  <a:extLst>
                    <a:ext uri="{9D8B030D-6E8A-4147-A177-3AD203B41FA5}">
                      <a16:colId xmlns:a16="http://schemas.microsoft.com/office/drawing/2014/main" val="1167396450"/>
                    </a:ext>
                  </a:extLst>
                </a:gridCol>
                <a:gridCol w="612559">
                  <a:extLst>
                    <a:ext uri="{9D8B030D-6E8A-4147-A177-3AD203B41FA5}">
                      <a16:colId xmlns:a16="http://schemas.microsoft.com/office/drawing/2014/main" val="590806578"/>
                    </a:ext>
                  </a:extLst>
                </a:gridCol>
                <a:gridCol w="745724">
                  <a:extLst>
                    <a:ext uri="{9D8B030D-6E8A-4147-A177-3AD203B41FA5}">
                      <a16:colId xmlns:a16="http://schemas.microsoft.com/office/drawing/2014/main" val="43989554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ministration </a:t>
                      </a: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ute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se (mg/kg)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</a:t>
                      </a: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es</a:t>
                      </a: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in</a:t>
                      </a: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sex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it-IT" sz="11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g</a:t>
                      </a: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C</a:t>
                      </a:r>
                      <a:r>
                        <a:rPr lang="it-IT" sz="1100" baseline="-25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st</a:t>
                      </a: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ng.hr/ml)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520519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b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zodone</a:t>
                      </a:r>
                      <a:endParaRPr lang="it-IT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s</a:t>
                      </a: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star</a:t>
                      </a: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ale 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53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6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465638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b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zodone</a:t>
                      </a:r>
                      <a:endParaRPr lang="it-IT" sz="11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b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bapentin</a:t>
                      </a:r>
                      <a:endParaRPr lang="it-IT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aperitoneal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it-IT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7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4520683"/>
                  </a:ext>
                </a:extLst>
              </a:tr>
            </a:tbl>
          </a:graphicData>
        </a:graphic>
      </p:graphicFrame>
      <p:sp>
        <p:nvSpPr>
          <p:cNvPr id="2" name="Rettangolo 1">
            <a:extLst>
              <a:ext uri="{FF2B5EF4-FFF2-40B4-BE49-F238E27FC236}">
                <a16:creationId xmlns:a16="http://schemas.microsoft.com/office/drawing/2014/main" id="{21B9E4FD-E8C0-441D-9FDD-76DEB170783F}"/>
              </a:ext>
            </a:extLst>
          </p:cNvPr>
          <p:cNvSpPr/>
          <p:nvPr/>
        </p:nvSpPr>
        <p:spPr>
          <a:xfrm>
            <a:off x="2994746" y="4348452"/>
            <a:ext cx="4516176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9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maximum plasma concentration;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r>
              <a:rPr lang="en-US" sz="9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st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area under the concentration time curve.</a:t>
            </a:r>
            <a:endParaRPr lang="it-IT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D14F92B8-7E52-4FF7-907C-ED284D4C60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9388319"/>
              </p:ext>
            </p:extLst>
          </p:nvPr>
        </p:nvGraphicFramePr>
        <p:xfrm>
          <a:off x="2994746" y="3654714"/>
          <a:ext cx="5376896" cy="693738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831529">
                  <a:extLst>
                    <a:ext uri="{9D8B030D-6E8A-4147-A177-3AD203B41FA5}">
                      <a16:colId xmlns:a16="http://schemas.microsoft.com/office/drawing/2014/main" val="2754193983"/>
                    </a:ext>
                  </a:extLst>
                </a:gridCol>
                <a:gridCol w="1100831">
                  <a:extLst>
                    <a:ext uri="{9D8B030D-6E8A-4147-A177-3AD203B41FA5}">
                      <a16:colId xmlns:a16="http://schemas.microsoft.com/office/drawing/2014/main" val="3394332095"/>
                    </a:ext>
                  </a:extLst>
                </a:gridCol>
                <a:gridCol w="621437">
                  <a:extLst>
                    <a:ext uri="{9D8B030D-6E8A-4147-A177-3AD203B41FA5}">
                      <a16:colId xmlns:a16="http://schemas.microsoft.com/office/drawing/2014/main" val="4272264895"/>
                    </a:ext>
                  </a:extLst>
                </a:gridCol>
                <a:gridCol w="683581">
                  <a:extLst>
                    <a:ext uri="{9D8B030D-6E8A-4147-A177-3AD203B41FA5}">
                      <a16:colId xmlns:a16="http://schemas.microsoft.com/office/drawing/2014/main" val="499580439"/>
                    </a:ext>
                  </a:extLst>
                </a:gridCol>
                <a:gridCol w="763480">
                  <a:extLst>
                    <a:ext uri="{9D8B030D-6E8A-4147-A177-3AD203B41FA5}">
                      <a16:colId xmlns:a16="http://schemas.microsoft.com/office/drawing/2014/main" val="1167396450"/>
                    </a:ext>
                  </a:extLst>
                </a:gridCol>
                <a:gridCol w="594803">
                  <a:extLst>
                    <a:ext uri="{9D8B030D-6E8A-4147-A177-3AD203B41FA5}">
                      <a16:colId xmlns:a16="http://schemas.microsoft.com/office/drawing/2014/main" val="590806578"/>
                    </a:ext>
                  </a:extLst>
                </a:gridCol>
                <a:gridCol w="781235">
                  <a:extLst>
                    <a:ext uri="{9D8B030D-6E8A-4147-A177-3AD203B41FA5}">
                      <a16:colId xmlns:a16="http://schemas.microsoft.com/office/drawing/2014/main" val="43989554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b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bapentin</a:t>
                      </a:r>
                      <a:endParaRPr lang="it-IT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aperitoneal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s</a:t>
                      </a: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star</a:t>
                      </a: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ale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50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600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465638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b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zodone</a:t>
                      </a:r>
                      <a:endParaRPr lang="it-IT" sz="11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it-IT" sz="1100" b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bapentin</a:t>
                      </a:r>
                      <a:endParaRPr lang="it-IT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a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aperitoneal</a:t>
                      </a:r>
                      <a:endParaRPr lang="it-IT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it-IT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it-IT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it-IT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25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it-IT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it-IT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550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45206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918574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82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arrone Beatrice</dc:creator>
  <cp:lastModifiedBy>Garrone Beatrice</cp:lastModifiedBy>
  <cp:revision>5</cp:revision>
  <dcterms:created xsi:type="dcterms:W3CDTF">2020-01-29T15:23:08Z</dcterms:created>
  <dcterms:modified xsi:type="dcterms:W3CDTF">2020-02-20T10:29:32Z</dcterms:modified>
</cp:coreProperties>
</file>